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>
        <p:scale>
          <a:sx n="74" d="100"/>
          <a:sy n="74" d="100"/>
        </p:scale>
        <p:origin x="376" y="-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7480918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723951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741875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507606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963804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147503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207576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015550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85765048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800983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IN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4054793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IN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IN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F51106-9738-4983-8C24-19F87FD97318}" type="datetimeFigureOut">
              <a:rPr lang="en-IN" smtClean="0"/>
              <a:t>26-10-2025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06FE61-73DC-4FCD-92CC-D990570D4B2F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80806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2"/>
          <a:srcRect l="940" t="4320" r="799" b="2750"/>
          <a:stretch/>
        </p:blipFill>
        <p:spPr>
          <a:xfrm>
            <a:off x="2554664" y="327543"/>
            <a:ext cx="7098384" cy="4121909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175619" y="4798243"/>
            <a:ext cx="8429536" cy="106465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IN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 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: 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mparison of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rmicute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to </a:t>
            </a:r>
            <a:r>
              <a:rPr lang="en-US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acteroides</a:t>
            </a:r>
            <a:r>
              <a:rPr lang="en-US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(F/B) Ratio in Case and Control Group.</a:t>
            </a:r>
            <a:endParaRPr lang="en-IN" dirty="0" smtClean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9037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5</TotalTime>
  <Words>19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ll</dc:creator>
  <cp:lastModifiedBy>Dell</cp:lastModifiedBy>
  <cp:revision>2</cp:revision>
  <dcterms:created xsi:type="dcterms:W3CDTF">2025-10-26T17:38:58Z</dcterms:created>
  <dcterms:modified xsi:type="dcterms:W3CDTF">2025-10-26T18:14:40Z</dcterms:modified>
</cp:coreProperties>
</file>